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2.xml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fr-FR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70ABA9B9-EFC6-4A61-BD2A-6E45D1C8EF65}" type="datetime">
              <a:rPr b="0" lang="fr-FR" sz="1200" spc="-1" strike="noStrike">
                <a:solidFill>
                  <a:srgbClr val="000000"/>
                </a:solidFill>
                <a:latin typeface="Calibri"/>
              </a:rPr>
              <a:t>29/08/26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fr-FR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0087983A-3E90-45FA-9F4A-A250ED1D76C2}" type="slidenum">
              <a:rPr b="0" lang="fr-FR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8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B9B98C24-89C8-412B-AD6D-7B24BB84DB41}" type="slidenum">
              <a:rPr b="0" lang="bg-BG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9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b">
            <a:no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9E8DC1C3-9387-437E-AD3F-E5C214FC814E}" type="slidenum">
              <a:rPr b="0" lang="bg-BG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11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fr-FR" sz="1200" spc="-1" strike="noStrike">
              <a:solidFill>
                <a:srgbClr val="000000"/>
              </a:solidFill>
              <a:latin typeface="Calibri"/>
              <a:ea typeface="Arial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476AD09D-0C45-4BAE-9673-108C1D065B9F}" type="slidenum">
              <a:rPr b="0" lang="bg-BG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b">
            <a:no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0729CBDC-3477-4EBF-A528-3999C2D65128}" type="slidenum">
              <a:rPr b="0" lang="bg-BG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4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15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fr-FR" sz="1200" spc="-1" strike="noStrike">
              <a:solidFill>
                <a:srgbClr val="000000"/>
              </a:solidFill>
              <a:latin typeface="Calibri"/>
              <a:ea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C279E3-FAEB-4B7B-8D88-14DD73B08AD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3F12C1-2159-4411-ACF6-BA40B648034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FF8FED-08F9-44EB-8AD0-8B2B11C6FFE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B7417A-AE13-4966-BF2D-E76EC28E799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28BB29-BDF8-4AB0-9B67-701C5061CE2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E5A737-2A03-4026-981F-0FBFF890525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7E7DBF-D2C2-4387-B320-79172F7F0CE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2A64D9-998E-4A8D-9C13-2CA504898AB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E5C5B1-E3A2-4DAC-9DAE-418A90530CF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DE4B04-B1EB-479C-9368-889AF45D56A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A2DED9-292A-404C-B188-E3453C7385A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379B70-1DCB-417B-AA7F-DFD8B668790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6F035281-CF76-48F1-8DDB-F0AAE1C282C5}" type="datetime">
              <a:rPr b="0" lang="fr-FR" sz="1200" spc="-1" strike="noStrike">
                <a:solidFill>
                  <a:srgbClr val="898989"/>
                </a:solidFill>
                <a:latin typeface="Calibri"/>
              </a:rPr>
              <a:t>29/08/26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410CBDFB-C2C6-4990-BE7C-6A6BDE54A31A}" type="slidenum">
              <a:rPr b="0" lang="fr-FR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slideLayout" Target="../slideLayouts/slideLayout1.xml"/><Relationship Id="rId7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image" Target="../media/image7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2" descr=""/>
          <p:cNvPicPr/>
          <p:nvPr/>
        </p:nvPicPr>
        <p:blipFill>
          <a:blip r:embed="rId1"/>
          <a:srcRect l="1220" t="0" r="0" b="0"/>
          <a:stretch/>
        </p:blipFill>
        <p:spPr>
          <a:xfrm>
            <a:off x="3457440" y="399960"/>
            <a:ext cx="2303640" cy="2108160"/>
          </a:xfrm>
          <a:prstGeom prst="rect">
            <a:avLst/>
          </a:prstGeom>
          <a:ln w="0">
            <a:noFill/>
          </a:ln>
        </p:spPr>
      </p:pic>
      <p:sp>
        <p:nvSpPr>
          <p:cNvPr id="49" name="Text Box 14"/>
          <p:cNvSpPr/>
          <p:nvPr/>
        </p:nvSpPr>
        <p:spPr>
          <a:xfrm>
            <a:off x="4147920" y="114480"/>
            <a:ext cx="1032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CD4 - gated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 Box 18"/>
          <p:cNvSpPr/>
          <p:nvPr/>
        </p:nvSpPr>
        <p:spPr>
          <a:xfrm>
            <a:off x="4179960" y="2509920"/>
            <a:ext cx="838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CD2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 Box 19"/>
          <p:cNvSpPr/>
          <p:nvPr/>
        </p:nvSpPr>
        <p:spPr>
          <a:xfrm rot="16200000">
            <a:off x="2901600" y="1223280"/>
            <a:ext cx="838440" cy="27648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CD127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 Box 96"/>
          <p:cNvSpPr/>
          <p:nvPr/>
        </p:nvSpPr>
        <p:spPr>
          <a:xfrm>
            <a:off x="158040" y="49320"/>
            <a:ext cx="3315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Text Box 74"/>
          <p:cNvSpPr/>
          <p:nvPr/>
        </p:nvSpPr>
        <p:spPr>
          <a:xfrm>
            <a:off x="5524920" y="6529320"/>
            <a:ext cx="3367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Supplementary Figure 1. </a:t>
            </a:r>
            <a:r>
              <a:rPr b="0" lang="fr-FR" sz="1600" spc="-1" strike="noStrike">
                <a:solidFill>
                  <a:srgbClr val="000000"/>
                </a:solidFill>
                <a:latin typeface="Calibri"/>
              </a:rPr>
              <a:t>Nikolova et al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Line 26"/>
          <p:cNvSpPr/>
          <p:nvPr/>
        </p:nvSpPr>
        <p:spPr>
          <a:xfrm>
            <a:off x="5113440" y="2178000"/>
            <a:ext cx="390600" cy="944640"/>
          </a:xfrm>
          <a:prstGeom prst="line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Line 25"/>
          <p:cNvSpPr/>
          <p:nvPr/>
        </p:nvSpPr>
        <p:spPr>
          <a:xfrm flipH="1">
            <a:off x="3684600" y="1800360"/>
            <a:ext cx="760320" cy="1279440"/>
          </a:xfrm>
          <a:prstGeom prst="line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Text Box 12"/>
          <p:cNvSpPr/>
          <p:nvPr/>
        </p:nvSpPr>
        <p:spPr>
          <a:xfrm>
            <a:off x="4022640" y="846000"/>
            <a:ext cx="838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Tac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Text Box 13"/>
          <p:cNvSpPr/>
          <p:nvPr/>
        </p:nvSpPr>
        <p:spPr>
          <a:xfrm>
            <a:off x="4635360" y="833400"/>
            <a:ext cx="755640" cy="5544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Treg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spcBef>
                <a:spcPts val="751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Line 30"/>
          <p:cNvSpPr/>
          <p:nvPr/>
        </p:nvSpPr>
        <p:spPr>
          <a:xfrm flipV="1">
            <a:off x="1905120" y="4481640"/>
            <a:ext cx="1828800" cy="144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ZoneTexte 46"/>
          <p:cNvSpPr/>
          <p:nvPr/>
        </p:nvSpPr>
        <p:spPr>
          <a:xfrm>
            <a:off x="2514600" y="4341960"/>
            <a:ext cx="644400" cy="276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Calibri"/>
              </a:rPr>
              <a:t>FoxP3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0" name="Picture 2" descr=""/>
          <p:cNvPicPr/>
          <p:nvPr/>
        </p:nvPicPr>
        <p:blipFill>
          <a:blip r:embed="rId2"/>
          <a:srcRect l="12418" t="11215" r="13052" b="14023"/>
          <a:stretch/>
        </p:blipFill>
        <p:spPr>
          <a:xfrm>
            <a:off x="1905120" y="3186000"/>
            <a:ext cx="1828800" cy="1219320"/>
          </a:xfrm>
          <a:prstGeom prst="rect">
            <a:avLst/>
          </a:prstGeom>
          <a:ln w="0">
            <a:noFill/>
          </a:ln>
        </p:spPr>
      </p:pic>
      <p:pic>
        <p:nvPicPr>
          <p:cNvPr id="61" name="Picture 3" descr=""/>
          <p:cNvPicPr/>
          <p:nvPr/>
        </p:nvPicPr>
        <p:blipFill>
          <a:blip r:embed="rId3"/>
          <a:srcRect l="9941" t="11215" r="13040" b="14023"/>
          <a:stretch/>
        </p:blipFill>
        <p:spPr>
          <a:xfrm>
            <a:off x="4800600" y="3186000"/>
            <a:ext cx="1889280" cy="1219320"/>
          </a:xfrm>
          <a:prstGeom prst="rect">
            <a:avLst/>
          </a:prstGeom>
          <a:ln w="0">
            <a:noFill/>
          </a:ln>
        </p:spPr>
      </p:pic>
      <p:sp>
        <p:nvSpPr>
          <p:cNvPr id="62" name="Line 30"/>
          <p:cNvSpPr/>
          <p:nvPr/>
        </p:nvSpPr>
        <p:spPr>
          <a:xfrm flipV="1">
            <a:off x="4876920" y="4481640"/>
            <a:ext cx="1828800" cy="144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ZoneTexte 46"/>
          <p:cNvSpPr/>
          <p:nvPr/>
        </p:nvSpPr>
        <p:spPr>
          <a:xfrm>
            <a:off x="5486400" y="4329000"/>
            <a:ext cx="644400" cy="276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Calibri"/>
              </a:rPr>
              <a:t>FoxP3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Line 30"/>
          <p:cNvSpPr/>
          <p:nvPr/>
        </p:nvSpPr>
        <p:spPr>
          <a:xfrm flipV="1">
            <a:off x="4876920" y="6108840"/>
            <a:ext cx="1828800" cy="144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ZoneTexte 46"/>
          <p:cNvSpPr/>
          <p:nvPr/>
        </p:nvSpPr>
        <p:spPr>
          <a:xfrm>
            <a:off x="5486400" y="5956200"/>
            <a:ext cx="644400" cy="276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Calibri"/>
              </a:rPr>
              <a:t>CD39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Line 30"/>
          <p:cNvSpPr/>
          <p:nvPr/>
        </p:nvSpPr>
        <p:spPr>
          <a:xfrm flipV="1">
            <a:off x="1905120" y="6108840"/>
            <a:ext cx="1828800" cy="144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ZoneTexte 46"/>
          <p:cNvSpPr/>
          <p:nvPr/>
        </p:nvSpPr>
        <p:spPr>
          <a:xfrm>
            <a:off x="2514600" y="5956200"/>
            <a:ext cx="644400" cy="276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Calibri"/>
              </a:rPr>
              <a:t>CD39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8" name="Picture 5" descr=""/>
          <p:cNvPicPr/>
          <p:nvPr/>
        </p:nvPicPr>
        <p:blipFill>
          <a:blip r:embed="rId4"/>
          <a:srcRect l="10635" t="13970" r="6316" b="18899"/>
          <a:stretch/>
        </p:blipFill>
        <p:spPr>
          <a:xfrm>
            <a:off x="1828800" y="4862520"/>
            <a:ext cx="1905120" cy="1111320"/>
          </a:xfrm>
          <a:prstGeom prst="rect">
            <a:avLst/>
          </a:prstGeom>
          <a:ln w="0">
            <a:noFill/>
          </a:ln>
        </p:spPr>
      </p:pic>
      <p:pic>
        <p:nvPicPr>
          <p:cNvPr id="69" name="Picture 29" descr=""/>
          <p:cNvPicPr/>
          <p:nvPr/>
        </p:nvPicPr>
        <p:blipFill>
          <a:blip r:embed="rId5"/>
          <a:srcRect l="10635" t="13830" r="6316" b="18899"/>
          <a:stretch/>
        </p:blipFill>
        <p:spPr>
          <a:xfrm>
            <a:off x="4800600" y="4862520"/>
            <a:ext cx="1905120" cy="11127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Rectangle 262"/>
          <p:cNvSpPr/>
          <p:nvPr/>
        </p:nvSpPr>
        <p:spPr>
          <a:xfrm>
            <a:off x="1181160" y="4130640"/>
            <a:ext cx="2743200" cy="1836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Rectangle 546"/>
          <p:cNvSpPr/>
          <p:nvPr/>
        </p:nvSpPr>
        <p:spPr>
          <a:xfrm>
            <a:off x="5511960" y="4073400"/>
            <a:ext cx="3079440" cy="1649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Text Box 96"/>
          <p:cNvSpPr/>
          <p:nvPr/>
        </p:nvSpPr>
        <p:spPr>
          <a:xfrm>
            <a:off x="160560" y="1776240"/>
            <a:ext cx="3438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3" name="Picture 543" descr=""/>
          <p:cNvPicPr/>
          <p:nvPr/>
        </p:nvPicPr>
        <p:blipFill>
          <a:blip r:embed="rId1"/>
          <a:srcRect l="0" t="0" r="0" b="3041"/>
          <a:stretch/>
        </p:blipFill>
        <p:spPr>
          <a:xfrm>
            <a:off x="4759200" y="2259000"/>
            <a:ext cx="4208760" cy="2681280"/>
          </a:xfrm>
          <a:prstGeom prst="rect">
            <a:avLst/>
          </a:prstGeom>
          <a:ln w="0">
            <a:noFill/>
          </a:ln>
        </p:spPr>
      </p:pic>
      <p:pic>
        <p:nvPicPr>
          <p:cNvPr id="74" name="Picture 542" descr=""/>
          <p:cNvPicPr/>
          <p:nvPr/>
        </p:nvPicPr>
        <p:blipFill>
          <a:blip r:embed="rId2"/>
          <a:srcRect l="0" t="0" r="0" b="3438"/>
          <a:stretch/>
        </p:blipFill>
        <p:spPr>
          <a:xfrm>
            <a:off x="189000" y="2336760"/>
            <a:ext cx="4273560" cy="2590920"/>
          </a:xfrm>
          <a:prstGeom prst="rect">
            <a:avLst/>
          </a:prstGeom>
          <a:ln w="0">
            <a:noFill/>
          </a:ln>
        </p:spPr>
      </p:pic>
      <p:sp>
        <p:nvSpPr>
          <p:cNvPr id="75" name="Text Box 96"/>
          <p:cNvSpPr/>
          <p:nvPr/>
        </p:nvSpPr>
        <p:spPr>
          <a:xfrm>
            <a:off x="4554000" y="1822320"/>
            <a:ext cx="30888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Calibri"/>
              </a:rPr>
              <a:t>c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76" name="Groupe 538"/>
          <p:cNvGrpSpPr/>
          <p:nvPr/>
        </p:nvGrpSpPr>
        <p:grpSpPr>
          <a:xfrm>
            <a:off x="1338120" y="1539720"/>
            <a:ext cx="2305080" cy="863640"/>
            <a:chOff x="1338120" y="1539720"/>
            <a:chExt cx="2305080" cy="863640"/>
          </a:xfrm>
        </p:grpSpPr>
        <p:grpSp>
          <p:nvGrpSpPr>
            <p:cNvPr id="77" name="Group 6"/>
            <p:cNvGrpSpPr/>
            <p:nvPr/>
          </p:nvGrpSpPr>
          <p:grpSpPr>
            <a:xfrm>
              <a:off x="1338120" y="2248560"/>
              <a:ext cx="2260080" cy="154800"/>
              <a:chOff x="1338120" y="2248560"/>
              <a:chExt cx="2260080" cy="154800"/>
            </a:xfrm>
          </p:grpSpPr>
          <p:sp>
            <p:nvSpPr>
              <p:cNvPr id="78" name="Line 7"/>
              <p:cNvSpPr/>
              <p:nvPr/>
            </p:nvSpPr>
            <p:spPr>
              <a:xfrm>
                <a:off x="1338120" y="2248560"/>
                <a:ext cx="22600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9" name="Line 8"/>
              <p:cNvSpPr/>
              <p:nvPr/>
            </p:nvSpPr>
            <p:spPr>
              <a:xfrm>
                <a:off x="1338120" y="2259720"/>
                <a:ext cx="0" cy="143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0" name="Line 9"/>
              <p:cNvSpPr/>
              <p:nvPr/>
            </p:nvSpPr>
            <p:spPr>
              <a:xfrm>
                <a:off x="3598200" y="2259720"/>
                <a:ext cx="0" cy="143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81" name="Text Box 10"/>
            <p:cNvSpPr/>
            <p:nvPr/>
          </p:nvSpPr>
          <p:spPr>
            <a:xfrm>
              <a:off x="2239920" y="2001240"/>
              <a:ext cx="4460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***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82" name="Group 11"/>
            <p:cNvGrpSpPr/>
            <p:nvPr/>
          </p:nvGrpSpPr>
          <p:grpSpPr>
            <a:xfrm>
              <a:off x="1372320" y="1787040"/>
              <a:ext cx="1056960" cy="110520"/>
              <a:chOff x="1372320" y="1787040"/>
              <a:chExt cx="1056960" cy="110520"/>
            </a:xfrm>
          </p:grpSpPr>
          <p:sp>
            <p:nvSpPr>
              <p:cNvPr id="83" name="Line 12"/>
              <p:cNvSpPr/>
              <p:nvPr/>
            </p:nvSpPr>
            <p:spPr>
              <a:xfrm>
                <a:off x="1372320" y="1787040"/>
                <a:ext cx="10515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4" name="Line 13"/>
              <p:cNvSpPr/>
              <p:nvPr/>
            </p:nvSpPr>
            <p:spPr>
              <a:xfrm>
                <a:off x="1372320" y="1787040"/>
                <a:ext cx="0" cy="110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5" name="Line 14"/>
              <p:cNvSpPr/>
              <p:nvPr/>
            </p:nvSpPr>
            <p:spPr>
              <a:xfrm>
                <a:off x="2429280" y="1787040"/>
                <a:ext cx="0" cy="110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86" name="Group 15"/>
            <p:cNvGrpSpPr/>
            <p:nvPr/>
          </p:nvGrpSpPr>
          <p:grpSpPr>
            <a:xfrm>
              <a:off x="2512080" y="1787040"/>
              <a:ext cx="1131120" cy="110520"/>
              <a:chOff x="2512080" y="1787040"/>
              <a:chExt cx="1131120" cy="110520"/>
            </a:xfrm>
          </p:grpSpPr>
          <p:sp>
            <p:nvSpPr>
              <p:cNvPr id="87" name="Line 16"/>
              <p:cNvSpPr/>
              <p:nvPr/>
            </p:nvSpPr>
            <p:spPr>
              <a:xfrm>
                <a:off x="2512080" y="1787040"/>
                <a:ext cx="11311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8" name="Line 17"/>
              <p:cNvSpPr/>
              <p:nvPr/>
            </p:nvSpPr>
            <p:spPr>
              <a:xfrm>
                <a:off x="2512080" y="1787040"/>
                <a:ext cx="0" cy="110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9" name="Line 18"/>
              <p:cNvSpPr/>
              <p:nvPr/>
            </p:nvSpPr>
            <p:spPr>
              <a:xfrm>
                <a:off x="3643200" y="1787040"/>
                <a:ext cx="0" cy="110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90" name="Text Box 19"/>
            <p:cNvSpPr/>
            <p:nvPr/>
          </p:nvSpPr>
          <p:spPr>
            <a:xfrm>
              <a:off x="1741680" y="1539720"/>
              <a:ext cx="3574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**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1" name="Text Box 20"/>
            <p:cNvSpPr/>
            <p:nvPr/>
          </p:nvSpPr>
          <p:spPr>
            <a:xfrm>
              <a:off x="2865600" y="1539720"/>
              <a:ext cx="3484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  </a:t>
              </a: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*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92" name="Groupe 540"/>
          <p:cNvGrpSpPr/>
          <p:nvPr/>
        </p:nvGrpSpPr>
        <p:grpSpPr>
          <a:xfrm>
            <a:off x="5835600" y="1508040"/>
            <a:ext cx="2147760" cy="816120"/>
            <a:chOff x="5835600" y="1508040"/>
            <a:chExt cx="2147760" cy="816120"/>
          </a:xfrm>
        </p:grpSpPr>
        <p:sp>
          <p:nvSpPr>
            <p:cNvPr id="93" name="Text Box 43"/>
            <p:cNvSpPr/>
            <p:nvPr/>
          </p:nvSpPr>
          <p:spPr>
            <a:xfrm>
              <a:off x="6673680" y="1932120"/>
              <a:ext cx="4460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***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4" name="Text Box 44"/>
            <p:cNvSpPr/>
            <p:nvPr/>
          </p:nvSpPr>
          <p:spPr>
            <a:xfrm>
              <a:off x="6199920" y="1521360"/>
              <a:ext cx="352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</a:rPr>
                <a:t>NS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95" name="Group 45"/>
            <p:cNvGrpSpPr/>
            <p:nvPr/>
          </p:nvGrpSpPr>
          <p:grpSpPr>
            <a:xfrm>
              <a:off x="6939720" y="1752480"/>
              <a:ext cx="1043640" cy="142560"/>
              <a:chOff x="6939720" y="1752480"/>
              <a:chExt cx="1043640" cy="142560"/>
            </a:xfrm>
          </p:grpSpPr>
          <p:sp>
            <p:nvSpPr>
              <p:cNvPr id="96" name="Line 46"/>
              <p:cNvSpPr/>
              <p:nvPr/>
            </p:nvSpPr>
            <p:spPr>
              <a:xfrm>
                <a:off x="6939720" y="1752480"/>
                <a:ext cx="10436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7" name="Line 47"/>
              <p:cNvSpPr/>
              <p:nvPr/>
            </p:nvSpPr>
            <p:spPr>
              <a:xfrm>
                <a:off x="6939720" y="1752480"/>
                <a:ext cx="0" cy="1425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8" name="Line 48"/>
              <p:cNvSpPr/>
              <p:nvPr/>
            </p:nvSpPr>
            <p:spPr>
              <a:xfrm>
                <a:off x="7983360" y="1752480"/>
                <a:ext cx="0" cy="1425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99" name="Text Box 51"/>
            <p:cNvSpPr/>
            <p:nvPr/>
          </p:nvSpPr>
          <p:spPr>
            <a:xfrm>
              <a:off x="7271280" y="1508040"/>
              <a:ext cx="2692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*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0" name="Line 32"/>
            <p:cNvSpPr/>
            <p:nvPr/>
          </p:nvSpPr>
          <p:spPr>
            <a:xfrm>
              <a:off x="5837040" y="2181240"/>
              <a:ext cx="21258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1" name="Line 33"/>
            <p:cNvSpPr/>
            <p:nvPr/>
          </p:nvSpPr>
          <p:spPr>
            <a:xfrm>
              <a:off x="5837040" y="2175120"/>
              <a:ext cx="0" cy="149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2" name="Line 34"/>
            <p:cNvSpPr/>
            <p:nvPr/>
          </p:nvSpPr>
          <p:spPr>
            <a:xfrm>
              <a:off x="7962840" y="2190960"/>
              <a:ext cx="0" cy="115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103" name="Group 39"/>
            <p:cNvGrpSpPr/>
            <p:nvPr/>
          </p:nvGrpSpPr>
          <p:grpSpPr>
            <a:xfrm>
              <a:off x="5835600" y="1752480"/>
              <a:ext cx="1024560" cy="142560"/>
              <a:chOff x="5835600" y="1752480"/>
              <a:chExt cx="1024560" cy="142560"/>
            </a:xfrm>
          </p:grpSpPr>
          <p:sp>
            <p:nvSpPr>
              <p:cNvPr id="104" name="Line 40"/>
              <p:cNvSpPr/>
              <p:nvPr/>
            </p:nvSpPr>
            <p:spPr>
              <a:xfrm>
                <a:off x="5835600" y="1752480"/>
                <a:ext cx="10245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5" name="Line 41"/>
              <p:cNvSpPr/>
              <p:nvPr/>
            </p:nvSpPr>
            <p:spPr>
              <a:xfrm>
                <a:off x="5835600" y="1752480"/>
                <a:ext cx="0" cy="1425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6" name="Line 42"/>
              <p:cNvSpPr/>
              <p:nvPr/>
            </p:nvSpPr>
            <p:spPr>
              <a:xfrm>
                <a:off x="6860160" y="1752480"/>
                <a:ext cx="0" cy="1425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sp>
        <p:nvSpPr>
          <p:cNvPr id="107" name="Text Box 74"/>
          <p:cNvSpPr/>
          <p:nvPr/>
        </p:nvSpPr>
        <p:spPr>
          <a:xfrm>
            <a:off x="4674960" y="6491160"/>
            <a:ext cx="43153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Supplementary Figure 1 </a:t>
            </a:r>
            <a:r>
              <a:rPr b="0" lang="fr-FR" sz="1600" spc="-1" strike="noStrike">
                <a:solidFill>
                  <a:srgbClr val="000000"/>
                </a:solidFill>
                <a:latin typeface="Calibri"/>
              </a:rPr>
              <a:t>Nikolova et al (continued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1-22T09:19:21Z</dcterms:created>
  <dc:creator>Lelièvre Jean-Daniel</dc:creator>
  <dc:description/>
  <dc:language>en-US</dc:language>
  <cp:lastModifiedBy>Lelièvre Jean-Daniel</cp:lastModifiedBy>
  <dcterms:modified xsi:type="dcterms:W3CDTF">2010-11-22T11:03:50Z</dcterms:modified>
  <cp:revision>2</cp:revision>
  <dc:subject/>
  <dc:title>Diapositive 1</dc:title>
</cp:coreProperties>
</file>